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59" r:id="rId2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008000"/>
    <a:srgbClr val="FF00FF"/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59" d="100"/>
          <a:sy n="59" d="100"/>
        </p:scale>
        <p:origin x="1098" y="60"/>
      </p:cViewPr>
      <p:guideLst>
        <p:guide orient="horz" pos="2137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r>
              <a:rPr kumimoji="1" lang="en-US" altLang="ja-JP" smtClean="0"/>
              <a:t>2017/3/2</a:t>
            </a:r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5AD636-6140-4181-898D-98C458BE7FB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0143873"/>
      </p:ext>
    </p:extLst>
  </p:cSld>
  <p:clrMap bg1="lt1" tx1="dk1" bg2="lt2" tx2="dk2" accent1="accent1" accent2="accent2" accent3="accent3" accent4="accent4" accent5="accent5" accent6="accent6" hlink="hlink" folHlink="folHlink"/>
  <p:hf sldNum="0" hdr="0" ftr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r>
              <a:rPr kumimoji="1" lang="en-US" altLang="ja-JP" smtClean="0"/>
              <a:t>2017/3/2</a:t>
            </a:r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9575" y="1233488"/>
            <a:ext cx="591661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748213"/>
            <a:ext cx="5389563" cy="38846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A5F2AE-7291-4DFC-B19E-0928D9A429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196194"/>
      </p:ext>
    </p:extLst>
  </p:cSld>
  <p:clrMap bg1="lt1" tx1="dk1" bg2="lt2" tx2="dk2" accent1="accent1" accent2="accent2" accent3="accent3" accent4="accent4" accent5="accent5" accent6="accent6" hlink="hlink" folHlink="folHlink"/>
  <p:hf sldNum="0" hdr="0" ftr="0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72585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45736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03663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1873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73830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64274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71117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08586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1656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85859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6112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70216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0" y="0"/>
            <a:ext cx="7569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>
                <a:latin typeface="Times New Roman" pitchFamily="18" charset="0"/>
                <a:cs typeface="Times New Roman" pitchFamily="18" charset="0"/>
              </a:rPr>
              <a:t>Fig</a:t>
            </a:r>
            <a:r>
              <a:rPr lang="en-US" altLang="ja-JP" sz="1400" b="1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ja-JP" sz="1400" b="1" dirty="0" smtClean="0">
                <a:latin typeface="Times New Roman" pitchFamily="18" charset="0"/>
                <a:cs typeface="Times New Roman" pitchFamily="18" charset="0"/>
              </a:rPr>
              <a:t>S1 </a:t>
            </a:r>
            <a:endParaRPr kumimoji="1" lang="ja-JP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2" name="図 11"/>
          <p:cNvPicPr preferRelativeResize="0"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447"/>
          <a:stretch/>
        </p:blipFill>
        <p:spPr>
          <a:xfrm>
            <a:off x="3142515" y="788950"/>
            <a:ext cx="2896794" cy="2082410"/>
          </a:xfrm>
          <a:prstGeom prst="rect">
            <a:avLst/>
          </a:prstGeom>
        </p:spPr>
      </p:pic>
      <p:sp>
        <p:nvSpPr>
          <p:cNvPr id="39" name="テキスト ボックス 38"/>
          <p:cNvSpPr txBox="1"/>
          <p:nvPr/>
        </p:nvSpPr>
        <p:spPr>
          <a:xfrm>
            <a:off x="3847760" y="566194"/>
            <a:ext cx="14863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i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ML4-ALK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variant 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図 12"/>
          <p:cNvPicPr preferRelativeResize="0"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84"/>
          <a:stretch/>
        </p:blipFill>
        <p:spPr>
          <a:xfrm>
            <a:off x="120420" y="804502"/>
            <a:ext cx="2885103" cy="2066858"/>
          </a:xfrm>
          <a:prstGeom prst="rect">
            <a:avLst/>
          </a:prstGeom>
        </p:spPr>
      </p:pic>
      <p:sp>
        <p:nvSpPr>
          <p:cNvPr id="20" name="テキスト ボックス 19"/>
          <p:cNvSpPr txBox="1"/>
          <p:nvPr/>
        </p:nvSpPr>
        <p:spPr>
          <a:xfrm>
            <a:off x="794171" y="572222"/>
            <a:ext cx="14863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i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ML4-ALK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variant 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ja-JP" altLang="en-US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1926268" y="1261150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NU-2535</a:t>
            </a:r>
            <a:endParaRPr kumimoji="1"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図 10"/>
          <p:cNvPicPr preferRelativeResize="0"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765"/>
          <a:stretch/>
        </p:blipFill>
        <p:spPr>
          <a:xfrm>
            <a:off x="6176301" y="806816"/>
            <a:ext cx="2883977" cy="2064544"/>
          </a:xfrm>
          <a:prstGeom prst="rect">
            <a:avLst/>
          </a:prstGeom>
        </p:spPr>
      </p:pic>
      <p:sp>
        <p:nvSpPr>
          <p:cNvPr id="6" name="テキスト ボックス 5"/>
          <p:cNvSpPr txBox="1"/>
          <p:nvPr/>
        </p:nvSpPr>
        <p:spPr>
          <a:xfrm>
            <a:off x="8247864" y="2268725"/>
            <a:ext cx="918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CI-H2228</a:t>
            </a:r>
            <a:endParaRPr kumimoji="1"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8143798" y="1012415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NU-2292</a:t>
            </a:r>
            <a:endParaRPr kumimoji="1"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6840672" y="572910"/>
            <a:ext cx="15552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i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ML4-ALK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variant 3a</a:t>
            </a:r>
            <a:endParaRPr kumimoji="1" lang="ja-JP" altLang="en-US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図 9"/>
          <p:cNvPicPr preferRelativeResize="0"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32"/>
          <a:stretch/>
        </p:blipFill>
        <p:spPr>
          <a:xfrm>
            <a:off x="9212299" y="804502"/>
            <a:ext cx="2883575" cy="2066858"/>
          </a:xfrm>
          <a:prstGeom prst="rect">
            <a:avLst/>
          </a:prstGeom>
        </p:spPr>
      </p:pic>
      <p:sp>
        <p:nvSpPr>
          <p:cNvPr id="41" name="テキスト ボックス 40"/>
          <p:cNvSpPr txBox="1"/>
          <p:nvPr/>
        </p:nvSpPr>
        <p:spPr>
          <a:xfrm>
            <a:off x="9872462" y="567404"/>
            <a:ext cx="1563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i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ML4-ALK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variant 3b</a:t>
            </a:r>
            <a:endParaRPr kumimoji="1" lang="ja-JP" altLang="en-US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099007" y="3688489"/>
            <a:ext cx="9300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i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F5B-RET</a:t>
            </a:r>
            <a:endParaRPr kumimoji="1" lang="ja-JP" altLang="en-US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図 15"/>
          <p:cNvPicPr preferRelativeResize="0"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41"/>
          <a:stretch/>
        </p:blipFill>
        <p:spPr>
          <a:xfrm>
            <a:off x="109774" y="3903446"/>
            <a:ext cx="2908528" cy="2082410"/>
          </a:xfrm>
          <a:prstGeom prst="rect">
            <a:avLst/>
          </a:prstGeom>
        </p:spPr>
      </p:pic>
      <p:grpSp>
        <p:nvGrpSpPr>
          <p:cNvPr id="25" name="グループ化 24"/>
          <p:cNvGrpSpPr/>
          <p:nvPr/>
        </p:nvGrpSpPr>
        <p:grpSpPr>
          <a:xfrm>
            <a:off x="3133067" y="3688489"/>
            <a:ext cx="2918627" cy="2297367"/>
            <a:chOff x="4026060" y="3688489"/>
            <a:chExt cx="2918627" cy="2297367"/>
          </a:xfrm>
        </p:grpSpPr>
        <p:sp>
          <p:nvSpPr>
            <p:cNvPr id="15" name="テキスト ボックス 14"/>
            <p:cNvSpPr txBox="1"/>
            <p:nvPr/>
          </p:nvSpPr>
          <p:spPr>
            <a:xfrm>
              <a:off x="4982672" y="3688489"/>
              <a:ext cx="10054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i="1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CDC6-RET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7" name="図 16"/>
            <p:cNvPicPr preferRelativeResize="0"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177"/>
            <a:stretch/>
          </p:blipFill>
          <p:spPr>
            <a:xfrm>
              <a:off x="4026060" y="3903446"/>
              <a:ext cx="2918627" cy="2082410"/>
            </a:xfrm>
            <a:prstGeom prst="rect">
              <a:avLst/>
            </a:prstGeom>
          </p:spPr>
        </p:pic>
        <p:sp>
          <p:nvSpPr>
            <p:cNvPr id="18" name="テキスト ボックス 17"/>
            <p:cNvSpPr txBox="1"/>
            <p:nvPr/>
          </p:nvSpPr>
          <p:spPr>
            <a:xfrm>
              <a:off x="6096000" y="4062592"/>
              <a:ext cx="6992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C-2/ad</a:t>
              </a:r>
              <a:endParaRPr lang="en-US" altLang="ja-JP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22" name="図 21"/>
          <p:cNvPicPr preferRelativeResize="0"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22"/>
          <a:stretch/>
        </p:blipFill>
        <p:spPr>
          <a:xfrm>
            <a:off x="7742791" y="3903446"/>
            <a:ext cx="2904979" cy="2082410"/>
          </a:xfrm>
          <a:prstGeom prst="rect">
            <a:avLst/>
          </a:prstGeom>
        </p:spPr>
      </p:pic>
      <p:sp>
        <p:nvSpPr>
          <p:cNvPr id="23" name="テキスト ボックス 22"/>
          <p:cNvSpPr txBox="1"/>
          <p:nvPr/>
        </p:nvSpPr>
        <p:spPr>
          <a:xfrm>
            <a:off x="8602810" y="3688489"/>
            <a:ext cx="1184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i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LC34A2-ROS1</a:t>
            </a:r>
            <a:endParaRPr kumimoji="1" lang="ja-JP" altLang="en-US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9724614" y="4115220"/>
            <a:ext cx="65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CC78</a:t>
            </a: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0" y="267903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kumimoji="1"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0" y="3546492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itchFamily="18" charset="0"/>
                <a:cs typeface="Times New Roman" pitchFamily="18" charset="0"/>
              </a:rPr>
              <a:t>b</a:t>
            </a:r>
            <a:endParaRPr kumimoji="1"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7078493" y="3582160"/>
            <a:ext cx="2984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itchFamily="18" charset="0"/>
                <a:cs typeface="Times New Roman" pitchFamily="18" charset="0"/>
              </a:rPr>
              <a:t>c</a:t>
            </a:r>
            <a:endParaRPr kumimoji="1"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76257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09</TotalTime>
  <Words>26</Words>
  <Application>Microsoft Office PowerPoint</Application>
  <PresentationFormat>ワイド画面</PresentationFormat>
  <Paragraphs>1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rugaki,Ko 古垣耕(プロダクトＲ部Ｏ育薬研究１Ｇ)</dc:creator>
  <cp:lastModifiedBy>Furugaki,Ko 古垣耕(プロダクトＲ部Ｏ育薬研究１Ｇ)</cp:lastModifiedBy>
  <cp:revision>195</cp:revision>
  <cp:lastPrinted>2017-03-13T01:57:05Z</cp:lastPrinted>
  <dcterms:created xsi:type="dcterms:W3CDTF">2016-11-14T09:26:54Z</dcterms:created>
  <dcterms:modified xsi:type="dcterms:W3CDTF">2017-09-22T13:47:07Z</dcterms:modified>
</cp:coreProperties>
</file>